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  <p:sldId id="271" r:id="rId4"/>
    <p:sldId id="268" r:id="rId5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>
      <p:cViewPr varScale="1">
        <p:scale>
          <a:sx n="112" d="100"/>
          <a:sy n="112" d="100"/>
        </p:scale>
        <p:origin x="252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3050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45454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29921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28600" y="228600"/>
            <a:ext cx="8534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eening of white mold disease of cabbage in 45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h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tional University cabbage (SCNU-C) lines inoculated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lerotior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graph taken at 5 days after inoculation (DAI). White-mold-resistant (R) and -susceptible (S) lines were defined according to the presence and absence of disease symptoms. 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1890121"/>
              </p:ext>
            </p:extLst>
          </p:nvPr>
        </p:nvGraphicFramePr>
        <p:xfrm>
          <a:off x="152400" y="1295400"/>
          <a:ext cx="8229599" cy="480907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75657"/>
                <a:gridCol w="1175657"/>
                <a:gridCol w="1175657"/>
                <a:gridCol w="1175657"/>
                <a:gridCol w="1175657"/>
                <a:gridCol w="1175657"/>
                <a:gridCol w="1175657"/>
              </a:tblGrid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o.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 name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I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o.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 name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I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03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295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07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297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09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299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13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00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16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02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21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05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28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08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30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12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33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27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35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31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41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38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49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41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51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45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55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46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56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47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60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61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61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363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62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406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065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407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107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409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170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411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270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419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  <a:tr h="2003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U-C-293</a:t>
                      </a: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473" marR="57473" marT="0" marB="0" anchor="ctr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03221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1</TotalTime>
  <Words>210</Words>
  <Application>Microsoft Office PowerPoint</Application>
  <PresentationFormat>On-screen Show (4:3)</PresentationFormat>
  <Paragraphs>14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f</dc:creator>
  <cp:lastModifiedBy>user</cp:lastModifiedBy>
  <cp:revision>50</cp:revision>
  <cp:lastPrinted>2018-09-20T20:45:46Z</cp:lastPrinted>
  <dcterms:created xsi:type="dcterms:W3CDTF">2006-08-16T00:00:00Z</dcterms:created>
  <dcterms:modified xsi:type="dcterms:W3CDTF">2018-12-13T01:24:07Z</dcterms:modified>
</cp:coreProperties>
</file>